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288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085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177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121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021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09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08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2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09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53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31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0444D-C728-4E93-AFFC-11AF6A8E28A4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85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3123316"/>
            <a:ext cx="3040380" cy="282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418" y="3123316"/>
            <a:ext cx="3040380" cy="282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1062674" y="30480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4495800" y="30480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0" y="6019800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arson correlatio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mpester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stagland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2, 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romboxan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2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toster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rostaglandin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D2,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romboxane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B2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ove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l brain structures (cortex, hippocampus, hypothalamus, and cerebellum, n=83) from male C57BL6/J aged 12 to 44 weeks and fed standard chow diet. 95% confidence interval is indicated as dashed line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5347734-944E-4C2E-830B-DD8343B4C6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420" y="109536"/>
            <a:ext cx="3040380" cy="282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D896BB6-AC4B-4753-8543-B9E488566D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109535"/>
            <a:ext cx="3040380" cy="282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E7C3B1B1-1A81-4017-83FE-4A5B6EF2BBB0}"/>
              </a:ext>
            </a:extLst>
          </p:cNvPr>
          <p:cNvSpPr txBox="1"/>
          <p:nvPr/>
        </p:nvSpPr>
        <p:spPr>
          <a:xfrm>
            <a:off x="1062674" y="3421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8F0B3DF-8A37-4F73-9DEF-275AEF3D439C}"/>
              </a:ext>
            </a:extLst>
          </p:cNvPr>
          <p:cNvSpPr txBox="1"/>
          <p:nvPr/>
        </p:nvSpPr>
        <p:spPr>
          <a:xfrm>
            <a:off x="4495800" y="3421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3124200" y="152400"/>
            <a:ext cx="102463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0.66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≤0.001 </a:t>
            </a:r>
            <a:endParaRPr lang="de-DE" sz="1200" dirty="0"/>
          </a:p>
        </p:txBody>
      </p:sp>
      <p:sp>
        <p:nvSpPr>
          <p:cNvPr id="12" name="Rechteck 11"/>
          <p:cNvSpPr/>
          <p:nvPr/>
        </p:nvSpPr>
        <p:spPr>
          <a:xfrm>
            <a:off x="6545553" y="152400"/>
            <a:ext cx="98135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69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≤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de-DE" sz="1200" dirty="0"/>
          </a:p>
        </p:txBody>
      </p:sp>
      <p:sp>
        <p:nvSpPr>
          <p:cNvPr id="13" name="Rechteck 12"/>
          <p:cNvSpPr/>
          <p:nvPr/>
        </p:nvSpPr>
        <p:spPr>
          <a:xfrm>
            <a:off x="3124200" y="3172599"/>
            <a:ext cx="98135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49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≤0.001</a:t>
            </a:r>
            <a:endParaRPr lang="de-DE" sz="1200" dirty="0"/>
          </a:p>
        </p:txBody>
      </p:sp>
      <p:sp>
        <p:nvSpPr>
          <p:cNvPr id="14" name="Rechteck 13"/>
          <p:cNvSpPr/>
          <p:nvPr/>
        </p:nvSpPr>
        <p:spPr>
          <a:xfrm>
            <a:off x="6545553" y="3172599"/>
            <a:ext cx="98135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446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≤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81007819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</Words>
  <Application>Microsoft Office PowerPoint</Application>
  <PresentationFormat>Bildschirmpräsentation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40</cp:revision>
  <cp:lastPrinted>2020-05-05T06:52:56Z</cp:lastPrinted>
  <dcterms:created xsi:type="dcterms:W3CDTF">2020-04-21T14:10:58Z</dcterms:created>
  <dcterms:modified xsi:type="dcterms:W3CDTF">2021-11-25T10:15:14Z</dcterms:modified>
</cp:coreProperties>
</file>